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2" userDrawn="1">
          <p15:clr>
            <a:srgbClr val="A4A3A4"/>
          </p15:clr>
        </p15:guide>
        <p15:guide id="2" pos="16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>
        <p:scale>
          <a:sx n="58" d="100"/>
          <a:sy n="58" d="100"/>
        </p:scale>
        <p:origin x="845" y="422"/>
      </p:cViewPr>
      <p:guideLst>
        <p:guide orient="horz" pos="432"/>
        <p:guide pos="16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35B3D4-93A3-7118-1C9B-DE55E91BD7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C814D7-1878-3B97-C926-174020B045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DD2F12-6168-DB2B-385D-362712F1B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A7260F-DA46-EFE8-9EE2-BA1C3FD81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FBF60F-F557-04F2-49D4-85868E609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98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5779D5-C9A8-E14B-B122-E887A89F45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8EE4A6-2900-CDCA-1C53-3259906BC6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2B574A-1B97-3B5F-D670-3BCD0F287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FBD1A9-B67C-6B42-67A9-4612726DA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F201E9-9B57-3F16-FC30-1E1AA400A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914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2CA9C2-9751-1BE1-7B21-1B5CA8D204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3B9547-57EA-621F-7203-3A5E0297CD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6BAA09-2E1A-B635-A7A9-9AE3C6098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61420B-D63D-FBD7-B3E5-3224B4663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090E4F-843B-0ED0-DE28-59DCD0A5BF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183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24B9CE-4D97-4EE1-E8C2-16BC87052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9A6909-9722-9B69-84D6-032B90D23F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BFC7B7-C49D-BF45-85F1-6D4C60BEF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D82E7-7576-9D41-1F5F-DDC135A66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70CD20-A04E-D39A-548F-D98489293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456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30CA71-DF45-CC86-988A-42D5B0555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720213-BC7A-2E90-E96F-D4B3693439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AAED53-C127-BA8B-1FAB-403E60767A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BCE208-8AA3-3463-1C9D-13EBCA20A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9060B2-F2BD-2732-516A-46A2501BF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59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4C35B-FFD9-5402-FAE6-5D81B40D0E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A3D63A-1ED0-59FC-9BDE-8333E44293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AA9A89-D17B-CACA-9BA7-8EC9534C91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6E2937-AE3D-F519-1FB1-0002D575B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207756-EF6D-4BBB-6453-58FB5A70D9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0A3446-087B-AE97-114E-542E7C57C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30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2616E-65E0-C740-96C5-4EE295A58D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0AABA4-8136-8F7F-EC24-ABFFE8EF3A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9F0A9D-0193-2477-2FCF-5C2879C90C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9B29418-C88C-21C3-AFEC-728E7D8316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E642E2-ABE1-57FD-A6E2-1A3C49AEB3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91418E-2FB8-17AD-A3E1-2BBD72904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CA4D72-B6F5-A578-1251-92CE89432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E847F8-C046-AFF5-C59A-7D5075BA2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908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232D2-BEB4-DF29-0936-57B09E1174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B65BD1-531C-9D18-BEDC-6FB400B09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F2B3A2-409E-B145-E823-176930482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936098-777C-9923-B8C2-1737F8297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99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877A38-3155-EA57-24D7-C08C968A0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CBB112-4221-C0C2-8783-A01D347B2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13B4FF-82C2-C95E-0B8F-3905FEA18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904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CAFD54-1C66-4C48-520F-70B6083B74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87ADF2-38C8-CFD9-79F9-3C2DDAF313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5D890B-3480-3702-9715-5BD9038468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1547BD-185B-AF9A-47DE-773CCDB86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958D46-742E-66E6-E7BD-9FCFD4001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A7AD91-F41C-5851-1F68-C85FFE34A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883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09DEDC-F9BE-4326-1F9A-840E872C5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3F6E3E-C20A-9ABC-D6BB-648C4BC32E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BBAF4A-AF47-1296-926F-54E61DA352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15A517-04C2-50B4-BD60-8AC11D4C60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D315AA-7BEA-E4DF-11F8-F00AFFF49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B785E8-3517-FA34-1156-C73D54EE8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81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EAA593-6B4C-9B77-0CAC-639E8BEE39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17DBA7-E109-1AA6-3618-3B2F4BD1B3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CBF0E-1395-4329-439D-DCDF6D750C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57CEE2-0497-45CE-89E7-BBD6011DDB09}" type="datetimeFigureOut">
              <a:rPr lang="en-US" smtClean="0"/>
              <a:t>1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30214D-38A4-3F7E-F702-095EB42631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F23247-DE8A-E29B-45F2-2A639C2650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4E8564-8E7A-4716-A703-CB4E8380B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49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C708D066-A585-AF48-22AC-C9324C7177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99589" y="299479"/>
            <a:ext cx="2663324" cy="271344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0BF51BB-D87E-05F1-6D5A-13EDC9EB86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6306" y="285388"/>
            <a:ext cx="2675592" cy="276283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12689BBF-716B-7C19-F424-D3C6860360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0372" y="259259"/>
            <a:ext cx="2693807" cy="278896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6307DD7-C65F-0F2C-9CA4-07E7E0DDE6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28330" y="277382"/>
            <a:ext cx="2713428" cy="279281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D6E4768-B2CC-1DA3-5A7B-5487275A397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01258" y="4014265"/>
            <a:ext cx="2663324" cy="267705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FC784F9-94A4-7041-F29E-4859290A44B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11121" y="3984141"/>
            <a:ext cx="2771161" cy="277116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D725B3E-A85D-F0A5-FF6C-80D3998501AD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r="4319"/>
          <a:stretch>
            <a:fillRect/>
          </a:stretch>
        </p:blipFill>
        <p:spPr>
          <a:xfrm>
            <a:off x="4793167" y="4017876"/>
            <a:ext cx="2651487" cy="283679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ED248F4-F927-199C-D8A1-19910A976A9E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/>
          <a:stretch>
            <a:fillRect/>
          </a:stretch>
        </p:blipFill>
        <p:spPr>
          <a:xfrm>
            <a:off x="2302879" y="3979876"/>
            <a:ext cx="2771161" cy="279281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BB723CD-4210-6A22-553A-B1425213444C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3020"/>
          <a:stretch>
            <a:fillRect/>
          </a:stretch>
        </p:blipFill>
        <p:spPr>
          <a:xfrm>
            <a:off x="45980" y="4005754"/>
            <a:ext cx="2563578" cy="281045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23AA267-5323-E912-E187-EF8CDE9B6941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1729" r="-1"/>
          <a:stretch>
            <a:fillRect/>
          </a:stretch>
        </p:blipFill>
        <p:spPr>
          <a:xfrm>
            <a:off x="20578" y="299479"/>
            <a:ext cx="2587735" cy="2764919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9684B36A-48FB-3AC4-93E7-2D3C54DCCD0C}"/>
              </a:ext>
            </a:extLst>
          </p:cNvPr>
          <p:cNvSpPr txBox="1"/>
          <p:nvPr/>
        </p:nvSpPr>
        <p:spPr>
          <a:xfrm>
            <a:off x="78189" y="10901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E4CB5CE-CA2A-4266-3825-CB37A9A03C21}"/>
              </a:ext>
            </a:extLst>
          </p:cNvPr>
          <p:cNvSpPr txBox="1"/>
          <p:nvPr/>
        </p:nvSpPr>
        <p:spPr>
          <a:xfrm>
            <a:off x="78189" y="360893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61C6A23-479D-45D3-ACC8-C635725FD5E5}"/>
              </a:ext>
            </a:extLst>
          </p:cNvPr>
          <p:cNvSpPr txBox="1"/>
          <p:nvPr/>
        </p:nvSpPr>
        <p:spPr>
          <a:xfrm>
            <a:off x="426318" y="217495"/>
            <a:ext cx="2260953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Basal tumors: Gene=TRAF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638290-F271-FDB6-E5CE-F62A8AF47203}"/>
              </a:ext>
            </a:extLst>
          </p:cNvPr>
          <p:cNvSpPr txBox="1"/>
          <p:nvPr/>
        </p:nvSpPr>
        <p:spPr>
          <a:xfrm>
            <a:off x="2608313" y="85314"/>
            <a:ext cx="2376698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HER2enriched tumors: Gene=TRAF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C6B47D2-FF3D-F4D1-B683-F92B6F257AB5}"/>
              </a:ext>
            </a:extLst>
          </p:cNvPr>
          <p:cNvSpPr txBox="1"/>
          <p:nvPr/>
        </p:nvSpPr>
        <p:spPr>
          <a:xfrm>
            <a:off x="4985011" y="193340"/>
            <a:ext cx="2449168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Luminal A tumors: Gene=TRAF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D4E796-E3DF-0142-3C7E-2BCB5AA9E298}"/>
              </a:ext>
            </a:extLst>
          </p:cNvPr>
          <p:cNvSpPr txBox="1"/>
          <p:nvPr/>
        </p:nvSpPr>
        <p:spPr>
          <a:xfrm>
            <a:off x="7444654" y="200111"/>
            <a:ext cx="2449168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Luminal B tumors: Gene=TRAF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CD98D5-30B5-8365-046E-FA1052C28CA2}"/>
              </a:ext>
            </a:extLst>
          </p:cNvPr>
          <p:cNvSpPr txBox="1"/>
          <p:nvPr/>
        </p:nvSpPr>
        <p:spPr>
          <a:xfrm>
            <a:off x="9742832" y="200111"/>
            <a:ext cx="2449168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Normal-like tumors: Gene=TRAF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DB718DF-33C2-8E07-30CD-AF32F11176C8}"/>
              </a:ext>
            </a:extLst>
          </p:cNvPr>
          <p:cNvSpPr txBox="1"/>
          <p:nvPr/>
        </p:nvSpPr>
        <p:spPr>
          <a:xfrm>
            <a:off x="475610" y="3928664"/>
            <a:ext cx="2260953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Basal tumors: Gene=TRAF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D68FBE2-BBC5-11E3-820A-08A015D802D2}"/>
              </a:ext>
            </a:extLst>
          </p:cNvPr>
          <p:cNvSpPr txBox="1"/>
          <p:nvPr/>
        </p:nvSpPr>
        <p:spPr>
          <a:xfrm>
            <a:off x="2687271" y="3787809"/>
            <a:ext cx="2376698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HER2enriched tumors: Gene=TRAF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8889D81-10CE-04E1-F517-C1152C4C99BD}"/>
              </a:ext>
            </a:extLst>
          </p:cNvPr>
          <p:cNvSpPr txBox="1"/>
          <p:nvPr/>
        </p:nvSpPr>
        <p:spPr>
          <a:xfrm>
            <a:off x="5068270" y="3884773"/>
            <a:ext cx="2449168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Luminal A tumors: Gene=TRAF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22371D1-39C5-FA37-C973-690EF7E17845}"/>
              </a:ext>
            </a:extLst>
          </p:cNvPr>
          <p:cNvSpPr txBox="1"/>
          <p:nvPr/>
        </p:nvSpPr>
        <p:spPr>
          <a:xfrm>
            <a:off x="7475276" y="3892018"/>
            <a:ext cx="2449168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Luminal B tumors: Gene=TRAF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B84F59C-0619-22A4-AF8A-52B2249D98D7}"/>
              </a:ext>
            </a:extLst>
          </p:cNvPr>
          <p:cNvSpPr txBox="1"/>
          <p:nvPr/>
        </p:nvSpPr>
        <p:spPr>
          <a:xfrm>
            <a:off x="9742832" y="3884773"/>
            <a:ext cx="2449168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All tumors: Subset=PAM50_Normal-like tumors: Gene=TRAF3</a:t>
            </a:r>
          </a:p>
        </p:txBody>
      </p:sp>
    </p:spTree>
    <p:extLst>
      <p:ext uri="{BB962C8B-B14F-4D97-AF65-F5344CB8AC3E}">
        <p14:creationId xmlns:p14="http://schemas.microsoft.com/office/powerpoint/2010/main" val="3431508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136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stasios Papanastasiou</dc:creator>
  <cp:lastModifiedBy>Anastasios Papanastasiou</cp:lastModifiedBy>
  <cp:revision>5</cp:revision>
  <dcterms:created xsi:type="dcterms:W3CDTF">2025-12-18T15:49:10Z</dcterms:created>
  <dcterms:modified xsi:type="dcterms:W3CDTF">2026-01-11T13:41:36Z</dcterms:modified>
</cp:coreProperties>
</file>